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7"/>
  </p:notesMasterIdLst>
  <p:sldIdLst>
    <p:sldId id="256" r:id="rId2"/>
    <p:sldId id="257" r:id="rId3"/>
    <p:sldId id="258" r:id="rId4"/>
    <p:sldId id="259" r:id="rId5"/>
    <p:sldId id="260" r:id="rId6"/>
  </p:sldIdLst>
  <p:sldSz cx="6858000" cy="9906000" type="A4"/>
  <p:notesSz cx="6858000" cy="9144000"/>
  <p:embeddedFontLst>
    <p:embeddedFont>
      <p:font typeface="Calibri" panose="020F0502020204030204" pitchFamily="34" charset="0"/>
      <p:regular r:id="rId8"/>
      <p:bold r:id="rId9"/>
      <p:italic r:id="rId10"/>
      <p:boldItalic r:id="rId11"/>
    </p:embeddedFont>
    <p:embeddedFont>
      <p:font typeface="Palatino Linotype" panose="02040502050505030304" pitchFamily="18" charset="0"/>
      <p:regular r:id="rId12"/>
      <p:bold r:id="rId13"/>
      <p:italic r:id="rId14"/>
      <p:boldItalic r:id="rId1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16" roundtripDataSignature="AMtx7mgh4bop/wigURjSML7tJ0LZw+GbEA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37" d="100"/>
          <a:sy n="37" d="100"/>
        </p:scale>
        <p:origin x="173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1.fntdata"/><Relationship Id="rId13" Type="http://schemas.openxmlformats.org/officeDocument/2006/relationships/font" Target="fonts/font6.fntdata"/><Relationship Id="rId1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font" Target="fonts/font5.fntdata"/><Relationship Id="rId17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customschemas.google.com/relationships/presentationmetadata" Target="metadata"/><Relationship Id="rId20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font" Target="fonts/font4.fntdata"/><Relationship Id="rId5" Type="http://schemas.openxmlformats.org/officeDocument/2006/relationships/slide" Target="slides/slide4.xml"/><Relationship Id="rId15" Type="http://schemas.openxmlformats.org/officeDocument/2006/relationships/font" Target="fonts/font8.fntdata"/><Relationship Id="rId10" Type="http://schemas.openxmlformats.org/officeDocument/2006/relationships/font" Target="fonts/font3.fntdata"/><Relationship Id="rId19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font" Target="fonts/font2.fntdata"/><Relationship Id="rId14" Type="http://schemas.openxmlformats.org/officeDocument/2006/relationships/font" Target="fonts/font7.fntdata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7" name="Google Shape;87;p2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8" name="Google Shape;88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3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" name="Google Shape;94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Google Shape;99;p4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0" name="Google Shape;100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5" name="Google Shape;105;p5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6" name="Google Shape;106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a titolo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7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7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testo verticale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6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1_Titolo e testo verticale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7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7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olo titolo" type="titleOnly">
  <p:cSld name="TITLE_ONLY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olo e contenuto" type="obj">
  <p:cSld name="OBJECT">
    <p:spTree>
      <p:nvGrpSpPr>
        <p:cNvPr id="1" name="Shape 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Google Shape;23;p9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9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5" name="Google Shape;25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testazione sezione" type="secHead">
  <p:cSld name="SECTION_HEADER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10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10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1" name="Google Shape;31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ue contenuti" type="twoObj">
  <p:cSld name="TWO_OBJECTS">
    <p:spTree>
      <p:nvGrpSpPr>
        <p:cNvPr id="1" name="Shape 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" name="Google Shape;35;p11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11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11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8" name="Google Shape;38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0" name="Google Shape;40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fronto" type="twoTxTwoObj">
  <p:cSld name="TWO_OBJECTS_WITH_TEXT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2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12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4" name="Google Shape;44;p12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5" name="Google Shape;45;p12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6" name="Google Shape;46;p12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7" name="Google Shape;47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uota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to con didascalia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4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4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4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magine con didascalia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5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5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5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N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4" name="Google Shape;84;p1" descr="Immagine che contiene testo&#10;&#10;Descrizione generata automaticament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218182" y="252673"/>
            <a:ext cx="2421636" cy="1735836"/>
          </a:xfrm>
          <a:prstGeom prst="rect">
            <a:avLst/>
          </a:prstGeom>
          <a:noFill/>
          <a:ln>
            <a:noFill/>
          </a:ln>
        </p:spPr>
      </p:pic>
      <p:sp>
        <p:nvSpPr>
          <p:cNvPr id="85" name="Google Shape;85;p1"/>
          <p:cNvSpPr txBox="1"/>
          <p:nvPr/>
        </p:nvSpPr>
        <p:spPr>
          <a:xfrm>
            <a:off x="316006" y="2188885"/>
            <a:ext cx="6225900" cy="191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i="0" u="none" strike="noStrike" cap="non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</a:t>
            </a:r>
            <a:r>
              <a:rPr lang="en-US" b="1">
                <a:latin typeface="Palatino Linotype"/>
                <a:ea typeface="Palatino Linotype"/>
                <a:cs typeface="Palatino Linotype"/>
                <a:sym typeface="Palatino Linotype"/>
              </a:rPr>
              <a:t>ure </a:t>
            </a:r>
            <a:r>
              <a:rPr lang="en-US" sz="1400" b="1" i="0" u="none" strike="noStrike" cap="non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S1. Cells detached due to CBD treatment are not dead. </a:t>
            </a:r>
            <a:r>
              <a:rPr lang="en-US" sz="1400" b="0" i="0" u="none" strike="noStrike" cap="non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Captured images of detached MDA-MB-231 cells able to re-adhere and grow to tissue culture plates after 72h CBD pre-treatment (DMEM with 0.5% FBS). 5 days after seeding without cannabidiol (in DMEM with 10% FBS), optical images were captured with an inverted Olympus CKX41 microscope. Scale bar: 50 µm. </a:t>
            </a:r>
            <a:endParaRPr sz="1400" b="0" i="0" u="none" strike="noStrike" cap="none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  <a:p>
            <a:pPr marL="0" marR="0" lvl="0" indent="0" algn="l" rtl="0">
              <a:spcBef>
                <a:spcPts val="800"/>
              </a:spcBef>
              <a:spcAft>
                <a:spcPts val="0"/>
              </a:spcAft>
              <a:buNone/>
            </a:pPr>
            <a:br>
              <a:rPr lang="en-US" sz="1400" b="0" i="0" u="none" strike="noStrike" cap="none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</a:br>
            <a:endParaRPr sz="140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0" name="Google Shape;90;p2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91740"/>
            <a:ext cx="6858000" cy="4854704"/>
          </a:xfrm>
          <a:prstGeom prst="rect">
            <a:avLst/>
          </a:prstGeom>
          <a:noFill/>
          <a:ln>
            <a:noFill/>
          </a:ln>
        </p:spPr>
      </p:pic>
      <p:sp>
        <p:nvSpPr>
          <p:cNvPr id="91" name="Google Shape;91;p2"/>
          <p:cNvSpPr txBox="1"/>
          <p:nvPr/>
        </p:nvSpPr>
        <p:spPr>
          <a:xfrm>
            <a:off x="457200" y="5196728"/>
            <a:ext cx="5943600" cy="191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</a:t>
            </a:r>
            <a:r>
              <a:rPr lang="en-US" b="1">
                <a:latin typeface="Palatino Linotype"/>
                <a:ea typeface="Palatino Linotype"/>
                <a:cs typeface="Palatino Linotype"/>
                <a:sym typeface="Palatino Linotype"/>
              </a:rPr>
              <a:t>ure</a:t>
            </a: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S2. MDA-MB-231 cells were sensitive only to cisplatin treatment. </a:t>
            </a:r>
            <a:r>
              <a:rPr lang="en-US" sz="1400" b="0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Dose-response of MDA-MB-231 cells treated with different chemotherapeutic agents. Cells were treated as described in Materials and Methods and 72h after the treatment cell viability was tested using MTT. DDP = cisplatin, 5-FU = 5-fluorouracil, Dox = doxorubicin. Data are expressed as mean ± S.E.M. from three independent experiments.</a:t>
            </a:r>
            <a:endParaRPr sz="1400" b="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  <a:p>
            <a:pPr marL="0" marR="0" lvl="0" indent="0" algn="just" rtl="0">
              <a:spcBef>
                <a:spcPts val="800"/>
              </a:spcBef>
              <a:spcAft>
                <a:spcPts val="0"/>
              </a:spcAft>
              <a:buNone/>
            </a:pPr>
            <a:br>
              <a:rPr lang="en-US" sz="140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</a:br>
            <a:endParaRPr sz="140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6" name="Google Shape;96;p3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2294382" y="164912"/>
            <a:ext cx="2269236" cy="3067812"/>
          </a:xfrm>
          <a:prstGeom prst="rect">
            <a:avLst/>
          </a:prstGeom>
          <a:noFill/>
          <a:ln>
            <a:noFill/>
          </a:ln>
        </p:spPr>
      </p:pic>
      <p:sp>
        <p:nvSpPr>
          <p:cNvPr id="97" name="Google Shape;97;p3"/>
          <p:cNvSpPr txBox="1"/>
          <p:nvPr/>
        </p:nvSpPr>
        <p:spPr>
          <a:xfrm>
            <a:off x="410136" y="3353747"/>
            <a:ext cx="6037800" cy="1918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</a:t>
            </a:r>
            <a:r>
              <a:rPr lang="en-US" b="1">
                <a:latin typeface="Palatino Linotype"/>
                <a:ea typeface="Palatino Linotype"/>
                <a:cs typeface="Palatino Linotype"/>
                <a:sym typeface="Palatino Linotype"/>
              </a:rPr>
              <a:t>ure</a:t>
            </a: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S3. CBD effects on the viability of MDA-MB-231 cells.</a:t>
            </a:r>
            <a:r>
              <a:rPr lang="en-US" sz="1400" b="0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MDA-MB-231 cells were treated with increasing concentrations of CBD (DMEM with 0.5% FBS). After 72h,  cell viability was tested using MTT. Data are expressed as mean ± S.E.M. from three independent experiments. Differences among groups were analyzed using one-way ANOVA followed by Dunnett’s post hoc test. *</a:t>
            </a:r>
            <a:r>
              <a:rPr lang="en-US" sz="1400" b="0" i="1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p</a:t>
            </a:r>
            <a:r>
              <a:rPr lang="en-US" sz="1400" b="0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&lt; 0.05, ****</a:t>
            </a:r>
            <a:r>
              <a:rPr lang="en-US" sz="1400" b="0" i="1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p</a:t>
            </a:r>
            <a:r>
              <a:rPr lang="en-US" sz="1400" b="0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&lt; 0.0001. </a:t>
            </a:r>
            <a:endParaRPr sz="1400" b="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  <a:p>
            <a:pPr marL="0" marR="0" lvl="0" indent="0" algn="l" rtl="0">
              <a:spcBef>
                <a:spcPts val="800"/>
              </a:spcBef>
              <a:spcAft>
                <a:spcPts val="0"/>
              </a:spcAft>
              <a:buNone/>
            </a:pPr>
            <a:br>
              <a:rPr lang="en-US" sz="140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</a:br>
            <a:endParaRPr sz="140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" name="Google Shape;102;p4" descr="Immagine che contiene mappa&#10;&#10;Descrizione generata automaticamente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95199"/>
            <a:ext cx="6858000" cy="3852696"/>
          </a:xfrm>
          <a:prstGeom prst="rect">
            <a:avLst/>
          </a:prstGeom>
          <a:noFill/>
          <a:ln>
            <a:noFill/>
          </a:ln>
        </p:spPr>
      </p:pic>
      <p:sp>
        <p:nvSpPr>
          <p:cNvPr id="103" name="Google Shape;103;p4"/>
          <p:cNvSpPr txBox="1"/>
          <p:nvPr/>
        </p:nvSpPr>
        <p:spPr>
          <a:xfrm>
            <a:off x="147919" y="4168588"/>
            <a:ext cx="6562200" cy="2349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</a:t>
            </a:r>
            <a:r>
              <a:rPr lang="en-US" b="1">
                <a:latin typeface="Palatino Linotype"/>
                <a:ea typeface="Palatino Linotype"/>
                <a:cs typeface="Palatino Linotype"/>
                <a:sym typeface="Palatino Linotype"/>
              </a:rPr>
              <a:t>ure</a:t>
            </a: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S4. Docking experiments revealed CBD binding sites near the C-terminal α-helix, a key player in IGF-1R receptor activation.</a:t>
            </a:r>
            <a:r>
              <a:rPr lang="en-US" sz="1400" b="0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(A) Model of a dimer conformation for inactive IGF-1R (PDB ID: 5u8r). (B) Structure of the active dimeric IGF-1R (PDB ID: 6pyh). The C-terminal α-helix (α-Ct for the A monomer indicated as IGF-1R, and α-Ct’ for the B monomer indicated as IGF-1R’) is evidenced in a different color, as indicated in the legend. The amino acids that make contact with the CBD in the docking experiments are highlighted in red.</a:t>
            </a:r>
            <a:endParaRPr sz="1400" b="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  <a:p>
            <a:pPr marL="0" marR="0" lvl="0" indent="0" algn="l" rtl="0">
              <a:spcBef>
                <a:spcPts val="800"/>
              </a:spcBef>
              <a:spcAft>
                <a:spcPts val="0"/>
              </a:spcAft>
              <a:buNone/>
            </a:pPr>
            <a:br>
              <a:rPr lang="en-US" sz="140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</a:br>
            <a:endParaRPr sz="140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8" name="Google Shape;108;p5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1405685" y="40341"/>
            <a:ext cx="4046631" cy="8216153"/>
          </a:xfrm>
          <a:prstGeom prst="rect">
            <a:avLst/>
          </a:prstGeom>
          <a:noFill/>
          <a:ln>
            <a:noFill/>
          </a:ln>
        </p:spPr>
      </p:pic>
      <p:sp>
        <p:nvSpPr>
          <p:cNvPr id="109" name="Google Shape;109;p5"/>
          <p:cNvSpPr txBox="1"/>
          <p:nvPr/>
        </p:nvSpPr>
        <p:spPr>
          <a:xfrm>
            <a:off x="158004" y="8471647"/>
            <a:ext cx="6542100" cy="1703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Fig</a:t>
            </a:r>
            <a:r>
              <a:rPr lang="en-US" b="1">
                <a:latin typeface="Palatino Linotype"/>
                <a:ea typeface="Palatino Linotype"/>
                <a:cs typeface="Palatino Linotype"/>
                <a:sym typeface="Palatino Linotype"/>
              </a:rPr>
              <a:t>ure</a:t>
            </a:r>
            <a:r>
              <a:rPr lang="en-US" sz="1400" b="1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 S5. IGF-1 antagonizes CBD effect on cellular morphology. </a:t>
            </a:r>
            <a:r>
              <a:rPr lang="en-US" sz="1400" b="0" i="0" u="none" strike="noStrike">
                <a:solidFill>
                  <a:srgbClr val="000000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  <a:t>Cellular morphology of MDA-MB-231 cells co-treated with 5µM CBD and increasing concentrations of IGF-1. After different time points (24,48 and 72h) optical images were captured with an inverted Olympus CKX41 microscope. Scale bar: 500µm. </a:t>
            </a:r>
            <a:endParaRPr sz="1400" b="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  <a:p>
            <a:pPr marL="0" marR="0" lvl="0" indent="0" algn="l" rtl="0">
              <a:spcBef>
                <a:spcPts val="800"/>
              </a:spcBef>
              <a:spcAft>
                <a:spcPts val="0"/>
              </a:spcAft>
              <a:buNone/>
            </a:pPr>
            <a:br>
              <a:rPr lang="en-US" sz="1400">
                <a:solidFill>
                  <a:schemeClr val="dk1"/>
                </a:solidFill>
                <a:latin typeface="Palatino Linotype"/>
                <a:ea typeface="Palatino Linotype"/>
                <a:cs typeface="Palatino Linotype"/>
                <a:sym typeface="Palatino Linotype"/>
              </a:rPr>
            </a:br>
            <a:endParaRPr sz="1400">
              <a:solidFill>
                <a:schemeClr val="dk1"/>
              </a:solidFill>
              <a:latin typeface="Palatino Linotype"/>
              <a:ea typeface="Palatino Linotype"/>
              <a:cs typeface="Palatino Linotype"/>
              <a:sym typeface="Palatino Linotype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87</Words>
  <Application>Microsoft Office PowerPoint</Application>
  <PresentationFormat>A4 (21x29,7 cm)</PresentationFormat>
  <Paragraphs>10</Paragraphs>
  <Slides>5</Slides>
  <Notes>5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9" baseType="lpstr">
      <vt:lpstr>Palatino Linotype</vt:lpstr>
      <vt:lpstr>Arial</vt:lpstr>
      <vt:lpstr>Calibri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essia.daloia@unimib.it</dc:creator>
  <cp:lastModifiedBy>barbara.costa@unimib.it</cp:lastModifiedBy>
  <cp:revision>1</cp:revision>
  <dcterms:created xsi:type="dcterms:W3CDTF">2022-04-07T08:56:43Z</dcterms:created>
  <dcterms:modified xsi:type="dcterms:W3CDTF">2022-04-25T13:52:19Z</dcterms:modified>
</cp:coreProperties>
</file>